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83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68CF05-75CE-D81B-3958-011A73ED1A3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4D0A9B5-4BAF-AA20-AD4F-5445568728F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FAA4643-CEAB-ED4A-81F1-B042D40928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2D0ED0D-4A3D-4FAA-F91B-CD55D9E1EB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012B51B-2E43-599A-6838-96430361FF3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435442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5773E9B-D4E7-E346-FB50-A41E0B8EFA7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D8F6E18-6FA5-C8C9-870D-6A40E72E8E0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61A1AC-85A5-56DF-9A62-FAA70B93149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2957D5-0C61-5DC0-82FB-9F74D60DC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FA46975-8E45-40EA-B91B-BBA29D67914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67533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DFD2956C-9585-C3A7-A934-74CA05A15B3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7EE2285-6BCE-8D45-2114-06BAE74C264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1FAA9F5-51A9-258E-4259-FFF32975716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89E6E3-3081-0DF3-9135-FED78B9762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18B459-4246-5546-2666-46848F6AAE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5820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B312D5-92DA-D71D-E7FF-1185C57EFC6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E493AC3-5838-5686-979F-C4708EAB9D1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2FBCBBE-C65A-1D9B-06AB-5A8291712B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5BD418-50AA-195E-9EF7-D37BD96474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13E518-5ACE-5576-44E5-BE929C49DE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411908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2AAB84-091F-22D5-3A6C-2DC3AAC4CA1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DD6B9BA-F627-D1E2-DB31-4985C5D2712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BEE6CB2-E836-6A59-C64E-F2318B43FB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B61097C-65E4-6523-D969-7CCE35A75B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5D3D516-7B6B-8815-EB85-192C470E32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510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1145D4-4F3E-DEF0-E52D-6F199945E74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EF7D364-D78F-5285-CFE5-28351C6CCBC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C2EEA0D-DFDD-70C7-2A63-AED7EAD1A1E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E2DA67F-4A1E-0861-4C09-6E66646B35A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3E79AA-DD26-89CD-01CC-9892E84063E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6D811C-07A8-0FBC-47D4-89DD4BA7BF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809103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B44007-89BB-BD77-871F-B1AA48E1B08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7168E8-01A6-B85D-F9AE-23C401953B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F7D23E6-9139-D575-2CCF-25C66474382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C19A8250-CF1B-3354-0556-08C73340F4E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45D328-D506-2928-BAF0-05A9108B5A9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6F467DC-86FD-CA63-923D-03A7C1B0946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14FF3B5-B688-9692-22E2-A444F44CC1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8097691A-9CD4-1274-14E1-AC55E5585D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80716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866D0E-AD11-EA47-B1DC-01D7E0AA515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5D4909-405A-165D-103C-1D7E95FD7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44D9572-0B1D-FE6F-EF95-F5E64844D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BBEEC9F-7990-93B9-A120-28D153D8B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06003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50903C99-819D-1F44-9492-1432839191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93F52CA-9FF0-30C6-E2D9-60B1E91C39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9E4D404-9C29-4F76-6AAF-687EEF66B5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3461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B456EAF-B526-28C9-72E1-15BAA3BE8DC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7D04110-9824-D35B-CF74-FFAA3E9565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6DC3187-603B-0CAB-38C7-E86921C0E73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B0FA8D5-E6AF-0212-F67F-ACFA6DFF9C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E1AD6B2-B43E-F50B-56D6-3F52696257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D916575-FF07-F808-8E6F-44012E5A04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28555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BD2E2D0-C57B-03DC-8B59-6147D3F057E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8CE6B405-2A04-9B3F-CAFC-16C41782685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BA778B-0D30-1763-F06E-00B2F19EF5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FE4BFAF-71E0-16DE-2FD1-F17396541D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1C6507B-296A-BE8A-004A-9B9C54CFED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0494F8C-3B05-AC5F-D984-D5693E3AB3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214156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508D78-3907-9E1F-6C27-99B43B6D19B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EB8E4-6EFD-207A-B4BB-B6258EB5D40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04AA7D4-7F64-B9D1-8B5C-9FF21ADEF1E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9FC2518-AE36-48D1-96F6-74333C097C54}" type="datetimeFigureOut">
              <a:rPr lang="en-GB" smtClean="0"/>
              <a:t>10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82A2B5-108F-6F70-32EE-A377B5418F7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1E433AA-3D25-AA0B-0995-A503FFCDF5C2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A00DCAB-198B-41CB-8970-0D756AE5DAC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576518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686234" y="1480654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M:CM (3:1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1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636412" y="148065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3735220-EE7B-5E13-CC53-B58E52BCBDF8}"/>
              </a:ext>
            </a:extLst>
          </p:cNvPr>
          <p:cNvSpPr txBox="1"/>
          <p:nvPr/>
        </p:nvSpPr>
        <p:spPr>
          <a:xfrm>
            <a:off x="3543240" y="148065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F6797-F4A4-323E-E7FE-B2DCA1291A82}"/>
              </a:ext>
            </a:extLst>
          </p:cNvPr>
          <p:cNvSpPr txBox="1"/>
          <p:nvPr/>
        </p:nvSpPr>
        <p:spPr>
          <a:xfrm>
            <a:off x="4824090" y="153348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32B6CC-99FA-9F02-628F-474EF9B77CA8}"/>
              </a:ext>
            </a:extLst>
          </p:cNvPr>
          <p:cNvSpPr txBox="1"/>
          <p:nvPr/>
        </p:nvSpPr>
        <p:spPr>
          <a:xfrm>
            <a:off x="5721774" y="153348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63446F9-80C1-C0AC-A2D1-47ED01D9DDB0}"/>
              </a:ext>
            </a:extLst>
          </p:cNvPr>
          <p:cNvSpPr txBox="1"/>
          <p:nvPr/>
        </p:nvSpPr>
        <p:spPr>
          <a:xfrm>
            <a:off x="2115606" y="1074108"/>
            <a:ext cx="26276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Plasmax</a:t>
            </a:r>
            <a:r>
              <a:rPr lang="en-GB" dirty="0"/>
              <a:t> (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-free)</a:t>
            </a:r>
            <a:endParaRPr lang="en-GB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dirty="0"/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900C7AAB-F23D-C8FE-6278-D8BE2EAFBFF4}"/>
              </a:ext>
            </a:extLst>
          </p:cNvPr>
          <p:cNvCxnSpPr/>
          <p:nvPr/>
        </p:nvCxnSpPr>
        <p:spPr>
          <a:xfrm>
            <a:off x="2342456" y="1457614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0176B5B7-442B-EFAE-5E24-DB4AD373B6A0}"/>
              </a:ext>
            </a:extLst>
          </p:cNvPr>
          <p:cNvCxnSpPr>
            <a:cxnSpLocks/>
          </p:cNvCxnSpPr>
          <p:nvPr/>
        </p:nvCxnSpPr>
        <p:spPr>
          <a:xfrm>
            <a:off x="2166126" y="1902816"/>
            <a:ext cx="0" cy="15261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A58E620-85D1-3DB1-1DAD-61B60CF3AA9E}"/>
              </a:ext>
            </a:extLst>
          </p:cNvPr>
          <p:cNvCxnSpPr>
            <a:cxnSpLocks/>
          </p:cNvCxnSpPr>
          <p:nvPr/>
        </p:nvCxnSpPr>
        <p:spPr>
          <a:xfrm>
            <a:off x="2162076" y="3756000"/>
            <a:ext cx="0" cy="15261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D077E99C-038F-58F5-CDA8-7FB6AC4EAC28}"/>
              </a:ext>
            </a:extLst>
          </p:cNvPr>
          <p:cNvSpPr txBox="1"/>
          <p:nvPr/>
        </p:nvSpPr>
        <p:spPr>
          <a:xfrm>
            <a:off x="987552" y="2665908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1E3218F-CD1A-7E0F-2A04-19DD6F248971}"/>
              </a:ext>
            </a:extLst>
          </p:cNvPr>
          <p:cNvSpPr txBox="1"/>
          <p:nvPr/>
        </p:nvSpPr>
        <p:spPr>
          <a:xfrm>
            <a:off x="719250" y="4334426"/>
            <a:ext cx="1450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errostatin-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5153549" y="1027941"/>
            <a:ext cx="1345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MEM/F-12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/>
          <p:nvPr/>
        </p:nvCxnSpPr>
        <p:spPr>
          <a:xfrm>
            <a:off x="4897396" y="1428910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7" name="Picture 36">
            <a:extLst>
              <a:ext uri="{FF2B5EF4-FFF2-40B4-BE49-F238E27FC236}">
                <a16:creationId xmlns:a16="http://schemas.microsoft.com/office/drawing/2014/main" id="{B6374EC6-D887-5C77-6BAA-30A2D357E5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26841" y="1873025"/>
            <a:ext cx="831176" cy="3600000"/>
          </a:xfrm>
          <a:prstGeom prst="rect">
            <a:avLst/>
          </a:prstGeom>
        </p:spPr>
      </p:pic>
      <p:pic>
        <p:nvPicPr>
          <p:cNvPr id="39" name="Picture 38">
            <a:extLst>
              <a:ext uri="{FF2B5EF4-FFF2-40B4-BE49-F238E27FC236}">
                <a16:creationId xmlns:a16="http://schemas.microsoft.com/office/drawing/2014/main" id="{B02A72B8-74DA-B46C-7AEE-745C5285E1D2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379149" y="1873025"/>
            <a:ext cx="831176" cy="3600000"/>
          </a:xfrm>
          <a:prstGeom prst="rect">
            <a:avLst/>
          </a:prstGeom>
        </p:spPr>
      </p:pic>
      <p:pic>
        <p:nvPicPr>
          <p:cNvPr id="41" name="Picture 40">
            <a:extLst>
              <a:ext uri="{FF2B5EF4-FFF2-40B4-BE49-F238E27FC236}">
                <a16:creationId xmlns:a16="http://schemas.microsoft.com/office/drawing/2014/main" id="{80422DC9-26C0-0DCE-6490-4D85303E7579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84562" y="1873025"/>
            <a:ext cx="831176" cy="3600000"/>
          </a:xfrm>
          <a:prstGeom prst="rect">
            <a:avLst/>
          </a:prstGeom>
        </p:spPr>
      </p:pic>
      <p:pic>
        <p:nvPicPr>
          <p:cNvPr id="43" name="Picture 42">
            <a:extLst>
              <a:ext uri="{FF2B5EF4-FFF2-40B4-BE49-F238E27FC236}">
                <a16:creationId xmlns:a16="http://schemas.microsoft.com/office/drawing/2014/main" id="{803621D5-CE7D-33EA-3DAC-D1E1C2C4DE9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438859" y="1873025"/>
            <a:ext cx="831176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8474437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686234" y="1480654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M:CM (3:1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2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636412" y="148065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3735220-EE7B-5E13-CC53-B58E52BCBDF8}"/>
              </a:ext>
            </a:extLst>
          </p:cNvPr>
          <p:cNvSpPr txBox="1"/>
          <p:nvPr/>
        </p:nvSpPr>
        <p:spPr>
          <a:xfrm>
            <a:off x="3607248" y="148065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F6797-F4A4-323E-E7FE-B2DCA1291A82}"/>
              </a:ext>
            </a:extLst>
          </p:cNvPr>
          <p:cNvSpPr txBox="1"/>
          <p:nvPr/>
        </p:nvSpPr>
        <p:spPr>
          <a:xfrm>
            <a:off x="4942962" y="153348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32B6CC-99FA-9F02-628F-474EF9B77CA8}"/>
              </a:ext>
            </a:extLst>
          </p:cNvPr>
          <p:cNvSpPr txBox="1"/>
          <p:nvPr/>
        </p:nvSpPr>
        <p:spPr>
          <a:xfrm>
            <a:off x="5986950" y="153348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2825CA1C-3CE4-A54D-0E93-161D1F3CEECE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3983" b="-16"/>
          <a:stretch/>
        </p:blipFill>
        <p:spPr>
          <a:xfrm>
            <a:off x="2292681" y="1849986"/>
            <a:ext cx="962367" cy="3639312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DBDD1889-7016-4564-F5D7-11B76B2401B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25091" y="1869642"/>
            <a:ext cx="949181" cy="36000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F63446F9-80C1-C0AC-A2D1-47ED01D9DDB0}"/>
              </a:ext>
            </a:extLst>
          </p:cNvPr>
          <p:cNvSpPr txBox="1"/>
          <p:nvPr/>
        </p:nvSpPr>
        <p:spPr>
          <a:xfrm>
            <a:off x="2115606" y="1074108"/>
            <a:ext cx="26276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Plasmax</a:t>
            </a:r>
            <a:r>
              <a:rPr lang="en-GB" dirty="0"/>
              <a:t> (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-free)</a:t>
            </a:r>
            <a:endParaRPr lang="en-GB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dirty="0"/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900C7AAB-F23D-C8FE-6278-D8BE2EAFBFF4}"/>
              </a:ext>
            </a:extLst>
          </p:cNvPr>
          <p:cNvCxnSpPr/>
          <p:nvPr/>
        </p:nvCxnSpPr>
        <p:spPr>
          <a:xfrm>
            <a:off x="2342456" y="1457614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0176B5B7-442B-EFAE-5E24-DB4AD373B6A0}"/>
              </a:ext>
            </a:extLst>
          </p:cNvPr>
          <p:cNvCxnSpPr>
            <a:cxnSpLocks/>
          </p:cNvCxnSpPr>
          <p:nvPr/>
        </p:nvCxnSpPr>
        <p:spPr>
          <a:xfrm>
            <a:off x="2166126" y="1902816"/>
            <a:ext cx="0" cy="15261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A58E620-85D1-3DB1-1DAD-61B60CF3AA9E}"/>
              </a:ext>
            </a:extLst>
          </p:cNvPr>
          <p:cNvCxnSpPr>
            <a:cxnSpLocks/>
          </p:cNvCxnSpPr>
          <p:nvPr/>
        </p:nvCxnSpPr>
        <p:spPr>
          <a:xfrm>
            <a:off x="2162076" y="3756000"/>
            <a:ext cx="0" cy="15261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D077E99C-038F-58F5-CDA8-7FB6AC4EAC28}"/>
              </a:ext>
            </a:extLst>
          </p:cNvPr>
          <p:cNvSpPr txBox="1"/>
          <p:nvPr/>
        </p:nvSpPr>
        <p:spPr>
          <a:xfrm>
            <a:off x="987552" y="2665908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</a:t>
            </a:r>
          </a:p>
        </p:txBody>
      </p:sp>
      <p:pic>
        <p:nvPicPr>
          <p:cNvPr id="30" name="Picture 29">
            <a:extLst>
              <a:ext uri="{FF2B5EF4-FFF2-40B4-BE49-F238E27FC236}">
                <a16:creationId xmlns:a16="http://schemas.microsoft.com/office/drawing/2014/main" id="{F251B14D-873F-9854-09CB-0E9E8572DE1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611109" y="1849986"/>
            <a:ext cx="949181" cy="3600000"/>
          </a:xfrm>
          <a:prstGeom prst="rect">
            <a:avLst/>
          </a:prstGeom>
        </p:spPr>
      </p:pic>
      <p:sp>
        <p:nvSpPr>
          <p:cNvPr id="31" name="TextBox 30">
            <a:extLst>
              <a:ext uri="{FF2B5EF4-FFF2-40B4-BE49-F238E27FC236}">
                <a16:creationId xmlns:a16="http://schemas.microsoft.com/office/drawing/2014/main" id="{B1E3218F-CD1A-7E0F-2A04-19DD6F248971}"/>
              </a:ext>
            </a:extLst>
          </p:cNvPr>
          <p:cNvSpPr txBox="1"/>
          <p:nvPr/>
        </p:nvSpPr>
        <p:spPr>
          <a:xfrm>
            <a:off x="719250" y="4334426"/>
            <a:ext cx="1450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errostatin-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5153549" y="1027941"/>
            <a:ext cx="1345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MEM/F-12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/>
          <p:nvPr/>
        </p:nvCxnSpPr>
        <p:spPr>
          <a:xfrm>
            <a:off x="4897396" y="1428910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35" name="Picture 34">
            <a:extLst>
              <a:ext uri="{FF2B5EF4-FFF2-40B4-BE49-F238E27FC236}">
                <a16:creationId xmlns:a16="http://schemas.microsoft.com/office/drawing/2014/main" id="{07A1A33D-AA59-1AD6-27A3-1179D4A8E41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64700" y="1849824"/>
            <a:ext cx="949181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555257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1A00302C-35D6-D2DE-0A2A-BEC7BD3B8499}"/>
              </a:ext>
            </a:extLst>
          </p:cNvPr>
          <p:cNvSpPr txBox="1"/>
          <p:nvPr/>
        </p:nvSpPr>
        <p:spPr>
          <a:xfrm>
            <a:off x="686234" y="1480654"/>
            <a:ext cx="14798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FM:CM (3:1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C418E9-2AC5-006F-B03A-FEDA89C3B7F8}"/>
              </a:ext>
            </a:extLst>
          </p:cNvPr>
          <p:cNvSpPr txBox="1"/>
          <p:nvPr/>
        </p:nvSpPr>
        <p:spPr>
          <a:xfrm>
            <a:off x="686234" y="397584"/>
            <a:ext cx="8386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Exp#3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32EB4046-3835-5259-EAEB-1C300DB6163A}"/>
              </a:ext>
            </a:extLst>
          </p:cNvPr>
          <p:cNvSpPr txBox="1"/>
          <p:nvPr/>
        </p:nvSpPr>
        <p:spPr>
          <a:xfrm>
            <a:off x="2636412" y="148065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3735220-EE7B-5E13-CC53-B58E52BCBDF8}"/>
              </a:ext>
            </a:extLst>
          </p:cNvPr>
          <p:cNvSpPr txBox="1"/>
          <p:nvPr/>
        </p:nvSpPr>
        <p:spPr>
          <a:xfrm>
            <a:off x="3662112" y="148065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247F6797-F4A4-323E-E7FE-B2DCA1291A82}"/>
              </a:ext>
            </a:extLst>
          </p:cNvPr>
          <p:cNvSpPr txBox="1"/>
          <p:nvPr/>
        </p:nvSpPr>
        <p:spPr>
          <a:xfrm>
            <a:off x="5098410" y="1533484"/>
            <a:ext cx="2616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8D32B6CC-99FA-9F02-628F-474EF9B77CA8}"/>
              </a:ext>
            </a:extLst>
          </p:cNvPr>
          <p:cNvSpPr txBox="1"/>
          <p:nvPr/>
        </p:nvSpPr>
        <p:spPr>
          <a:xfrm>
            <a:off x="6178974" y="1533484"/>
            <a:ext cx="31931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F63446F9-80C1-C0AC-A2D1-47ED01D9DDB0}"/>
              </a:ext>
            </a:extLst>
          </p:cNvPr>
          <p:cNvSpPr txBox="1"/>
          <p:nvPr/>
        </p:nvSpPr>
        <p:spPr>
          <a:xfrm>
            <a:off x="2115606" y="1074108"/>
            <a:ext cx="262764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 err="1"/>
              <a:t>Plasmax</a:t>
            </a:r>
            <a:r>
              <a:rPr lang="en-GB" dirty="0"/>
              <a:t> (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Na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SeO</a:t>
            </a:r>
            <a:r>
              <a:rPr lang="en-GB" baseline="-25000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GB" dirty="0">
                <a:latin typeface="Arial" panose="020B0604020202020204" pitchFamily="34" charset="0"/>
                <a:cs typeface="Arial" panose="020B0604020202020204" pitchFamily="34" charset="0"/>
              </a:rPr>
              <a:t>-free)</a:t>
            </a:r>
            <a:endParaRPr lang="en-GB" baseline="-25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GB" dirty="0"/>
          </a:p>
        </p:txBody>
      </p:sp>
      <p:cxnSp>
        <p:nvCxnSpPr>
          <p:cNvPr id="23" name="Straight Connector 22">
            <a:extLst>
              <a:ext uri="{FF2B5EF4-FFF2-40B4-BE49-F238E27FC236}">
                <a16:creationId xmlns:a16="http://schemas.microsoft.com/office/drawing/2014/main" id="{900C7AAB-F23D-C8FE-6278-D8BE2EAFBFF4}"/>
              </a:ext>
            </a:extLst>
          </p:cNvPr>
          <p:cNvCxnSpPr/>
          <p:nvPr/>
        </p:nvCxnSpPr>
        <p:spPr>
          <a:xfrm>
            <a:off x="2342456" y="1457614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4" name="Straight Connector 23">
            <a:extLst>
              <a:ext uri="{FF2B5EF4-FFF2-40B4-BE49-F238E27FC236}">
                <a16:creationId xmlns:a16="http://schemas.microsoft.com/office/drawing/2014/main" id="{0176B5B7-442B-EFAE-5E24-DB4AD373B6A0}"/>
              </a:ext>
            </a:extLst>
          </p:cNvPr>
          <p:cNvCxnSpPr>
            <a:cxnSpLocks/>
          </p:cNvCxnSpPr>
          <p:nvPr/>
        </p:nvCxnSpPr>
        <p:spPr>
          <a:xfrm>
            <a:off x="2166126" y="1902816"/>
            <a:ext cx="0" cy="15261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7" name="Straight Connector 26">
            <a:extLst>
              <a:ext uri="{FF2B5EF4-FFF2-40B4-BE49-F238E27FC236}">
                <a16:creationId xmlns:a16="http://schemas.microsoft.com/office/drawing/2014/main" id="{DA58E620-85D1-3DB1-1DAD-61B60CF3AA9E}"/>
              </a:ext>
            </a:extLst>
          </p:cNvPr>
          <p:cNvCxnSpPr>
            <a:cxnSpLocks/>
          </p:cNvCxnSpPr>
          <p:nvPr/>
        </p:nvCxnSpPr>
        <p:spPr>
          <a:xfrm>
            <a:off x="2162076" y="3756000"/>
            <a:ext cx="0" cy="1526184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>
            <a:extLst>
              <a:ext uri="{FF2B5EF4-FFF2-40B4-BE49-F238E27FC236}">
                <a16:creationId xmlns:a16="http://schemas.microsoft.com/office/drawing/2014/main" id="{D077E99C-038F-58F5-CDA8-7FB6AC4EAC28}"/>
              </a:ext>
            </a:extLst>
          </p:cNvPr>
          <p:cNvSpPr txBox="1"/>
          <p:nvPr/>
        </p:nvSpPr>
        <p:spPr>
          <a:xfrm>
            <a:off x="987552" y="2665908"/>
            <a:ext cx="89255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vehicle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B1E3218F-CD1A-7E0F-2A04-19DD6F248971}"/>
              </a:ext>
            </a:extLst>
          </p:cNvPr>
          <p:cNvSpPr txBox="1"/>
          <p:nvPr/>
        </p:nvSpPr>
        <p:spPr>
          <a:xfrm>
            <a:off x="719250" y="4334426"/>
            <a:ext cx="14505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errostatin-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F7183868-3A33-870B-9834-E90B67AF8C4F}"/>
              </a:ext>
            </a:extLst>
          </p:cNvPr>
          <p:cNvSpPr txBox="1"/>
          <p:nvPr/>
        </p:nvSpPr>
        <p:spPr>
          <a:xfrm>
            <a:off x="5153549" y="1027941"/>
            <a:ext cx="134549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DMEM/F-12</a:t>
            </a:r>
          </a:p>
        </p:txBody>
      </p:sp>
      <p:cxnSp>
        <p:nvCxnSpPr>
          <p:cNvPr id="33" name="Straight Connector 32">
            <a:extLst>
              <a:ext uri="{FF2B5EF4-FFF2-40B4-BE49-F238E27FC236}">
                <a16:creationId xmlns:a16="http://schemas.microsoft.com/office/drawing/2014/main" id="{7D401964-11F1-D2E9-F955-E0346753F145}"/>
              </a:ext>
            </a:extLst>
          </p:cNvPr>
          <p:cNvCxnSpPr/>
          <p:nvPr/>
        </p:nvCxnSpPr>
        <p:spPr>
          <a:xfrm>
            <a:off x="4897396" y="1428910"/>
            <a:ext cx="1857804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7" name="Picture 6">
            <a:extLst>
              <a:ext uri="{FF2B5EF4-FFF2-40B4-BE49-F238E27FC236}">
                <a16:creationId xmlns:a16="http://schemas.microsoft.com/office/drawing/2014/main" id="{8E0D55EC-AFF8-1138-0967-97F20DB7635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14646" y="1777346"/>
            <a:ext cx="956712" cy="3600000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ADCE6748-F7AC-70B8-CE4F-07A517B5117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36320" y="1777346"/>
            <a:ext cx="956712" cy="3600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4C010E0-4B6E-CF15-A95C-7285810EACC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45089" y="1800478"/>
            <a:ext cx="956712" cy="3600000"/>
          </a:xfrm>
          <a:prstGeom prst="rect">
            <a:avLst/>
          </a:prstGeom>
        </p:spPr>
      </p:pic>
      <p:pic>
        <p:nvPicPr>
          <p:cNvPr id="16" name="Picture 15">
            <a:extLst>
              <a:ext uri="{FF2B5EF4-FFF2-40B4-BE49-F238E27FC236}">
                <a16:creationId xmlns:a16="http://schemas.microsoft.com/office/drawing/2014/main" id="{F035FB84-EC5A-CEFC-AE04-8F672F0F5D2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872235" y="1800478"/>
            <a:ext cx="956712" cy="3600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1212970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59</TotalTime>
  <Words>66</Words>
  <Application>Microsoft Office PowerPoint</Application>
  <PresentationFormat>Widescreen</PresentationFormat>
  <Paragraphs>30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ptos</vt:lpstr>
      <vt:lpstr>Aptos Display</vt:lpstr>
      <vt:lpstr>Arial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Tobias Ackermann</dc:creator>
  <cp:lastModifiedBy>Tobias Ackermann</cp:lastModifiedBy>
  <cp:revision>15</cp:revision>
  <dcterms:created xsi:type="dcterms:W3CDTF">2024-06-06T16:34:22Z</dcterms:created>
  <dcterms:modified xsi:type="dcterms:W3CDTF">2024-06-11T18:45:10Z</dcterms:modified>
</cp:coreProperties>
</file>